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4618" r:id="rId2"/>
    <p:sldId id="461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121" d="100"/>
          <a:sy n="121" d="100"/>
        </p:scale>
        <p:origin x="39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C49308C-E421-2C4A-9F44-AC00FFAD190A}" type="datetimeFigureOut">
              <a:rPr lang="en-US" smtClean="0"/>
              <a:t>4/2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D81D7BB-2297-3D4B-84DC-1ABF64FB5C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850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D81D7BB-2297-3D4B-84DC-1ABF64FB5CF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595843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AD75D6F-1121-904C-B2CD-8256AB7BAA75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716391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48B556-EE1B-1C02-72AA-53E846F6DE9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8D777A4-E463-8586-7BDA-EE5D8195B91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8CE3A6-82A9-A363-758C-05DF26C706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8BF54-6490-F049-BA88-4E130049FA2D}" type="datetimeFigureOut">
              <a:rPr lang="en-US" smtClean="0"/>
              <a:t>4/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DAED9E-D8ED-70C7-F166-642285F089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92CD5D-8E96-B302-4012-D5D8BC6BD7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A5599-E721-EE4E-AA66-DE9A9B96A4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37360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8DD456-6E00-5CC4-83FB-F4F3957E64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C4F7131-9987-9E87-0BE7-2FFC9ED7F1B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5ECECF-9C06-36EF-A836-C7FEE9C955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8BF54-6490-F049-BA88-4E130049FA2D}" type="datetimeFigureOut">
              <a:rPr lang="en-US" smtClean="0"/>
              <a:t>4/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D8A704-5AD4-2BDC-73BF-1BA4A87487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A039AB-2353-9E41-C862-307C39F724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A5599-E721-EE4E-AA66-DE9A9B96A4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95071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2FFE3B2-23E1-ADDE-2CC4-003BF9F00E3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1C80FDF-E06F-E68A-FC60-D2E6AAA9683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25409B-88F8-EF03-7E1D-447E0A1CF2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8BF54-6490-F049-BA88-4E130049FA2D}" type="datetimeFigureOut">
              <a:rPr lang="en-US" smtClean="0"/>
              <a:t>4/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069FB3-6D21-6BB4-FB7F-7182D4B6CA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82F022-650A-DA8D-0D3D-DF1DA34A4C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A5599-E721-EE4E-AA66-DE9A9B96A4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6040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0F2ABD-E672-E981-B3B7-B6C86B07A0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C250D7B-DFCD-79BF-4846-94E70E1022F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68BDA0-3D8B-F4A7-9418-A040D99341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8BF54-6490-F049-BA88-4E130049FA2D}" type="datetimeFigureOut">
              <a:rPr lang="en-US" smtClean="0"/>
              <a:t>4/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24AAA2-C6A5-B95E-E72F-CC833BD562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F2942F-54A5-573D-245A-E8C01A7AF5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A5599-E721-EE4E-AA66-DE9A9B96A4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47284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EC000A-70BD-2598-6848-67C4C48AFC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F38E6AD-AD54-216F-AAA6-B06E1B57A8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06354A-67E2-933A-8D0E-C7C5C11648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8BF54-6490-F049-BA88-4E130049FA2D}" type="datetimeFigureOut">
              <a:rPr lang="en-US" smtClean="0"/>
              <a:t>4/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5F136B-E335-D1ED-42E6-349121157B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07B480-6D8B-2FC2-F763-C930216082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A5599-E721-EE4E-AA66-DE9A9B96A4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75721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FD8BF7-F904-37C9-8DEE-3F12252EFF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3D8C000-D3FE-082E-E7DE-6B14452B46E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C7C1848-47B6-0358-18CC-16F48FFDB5B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AF212E1-B234-CDF9-15FF-FFA3D1BA91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8BF54-6490-F049-BA88-4E130049FA2D}" type="datetimeFigureOut">
              <a:rPr lang="en-US" smtClean="0"/>
              <a:t>4/2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8FE1449-9A6B-CC75-E1CB-997552C223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BEA1474-A197-C22A-D511-5FA8BF990D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A5599-E721-EE4E-AA66-DE9A9B96A4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6870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303D62-4E03-E24F-BF4F-440505737D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FD2D0A6-0389-9FFF-1198-44EB3AF4B5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8B4FFB3-9C8C-AB55-58B5-D5B66DC60AC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0423E32-6F96-9455-84B2-ADBA10E0B3B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35200F3-282D-6EA2-C9A9-41CB20FD68B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D8C801E-FA97-E459-D7C1-DF3318311C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8BF54-6490-F049-BA88-4E130049FA2D}" type="datetimeFigureOut">
              <a:rPr lang="en-US" smtClean="0"/>
              <a:t>4/2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27EC7F3-DA36-7213-6B04-72AB8FB163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49763B1-D60E-07F9-7907-3A0EC98315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A5599-E721-EE4E-AA66-DE9A9B96A4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17327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E84D0A-D23D-2CA4-5489-3C601E2F2F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44C5419-55F2-7E41-3DBD-A17F2A282C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8BF54-6490-F049-BA88-4E130049FA2D}" type="datetimeFigureOut">
              <a:rPr lang="en-US" smtClean="0"/>
              <a:t>4/2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3822A51-572D-E72E-06E3-EA5993A43F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FE37040-630F-5BA4-A547-142B81A054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A5599-E721-EE4E-AA66-DE9A9B96A4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11912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6149904-A234-C0A6-A4FF-D6B738BDD7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8BF54-6490-F049-BA88-4E130049FA2D}" type="datetimeFigureOut">
              <a:rPr lang="en-US" smtClean="0"/>
              <a:t>4/2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D680F0E-E72C-A6B0-78A8-3F47309D30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499E1B6-5E46-EFC0-B84B-B5CCEDBB33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A5599-E721-EE4E-AA66-DE9A9B96A4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4511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BF8BF4-A248-D264-FE98-AB7EC09126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8E0DDF5-C5FB-E4CA-DA44-E52B69B2239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90372AF-6EFB-66F5-5BAC-D6FF27DC985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78E8217-1B84-6821-9086-E5D122CE96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8BF54-6490-F049-BA88-4E130049FA2D}" type="datetimeFigureOut">
              <a:rPr lang="en-US" smtClean="0"/>
              <a:t>4/2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AD35523-6EFE-0858-9697-7F6D10134C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8831198-3425-DB5B-BAC7-6E76B27D80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A5599-E721-EE4E-AA66-DE9A9B96A4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21647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47FCC0-B23C-B32A-FB92-5373BCC696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2DE4E2B-6C00-5DE2-4D41-61BEDCE060F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FD21B79-E645-3884-54A7-1A357CCFC6E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48ECD35-0C8A-285A-B33D-74A30DA45D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8BF54-6490-F049-BA88-4E130049FA2D}" type="datetimeFigureOut">
              <a:rPr lang="en-US" smtClean="0"/>
              <a:t>4/2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5FFEAB3-3047-572A-1F44-CFB40D81CC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1653D9B-EF2D-0A32-F6AE-280269A2A4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A5599-E721-EE4E-AA66-DE9A9B96A4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1760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4D63629-29F6-D14E-3D36-CBF7CCC195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1E3BB9B-C8C5-A962-86BC-EFAB589F0C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D724C9-0DBF-40F4-F8C7-B6BCFE1B5A9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7B8BF54-6490-F049-BA88-4E130049FA2D}" type="datetimeFigureOut">
              <a:rPr lang="en-US" smtClean="0"/>
              <a:t>4/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1736A2-8E46-801D-9DC0-E33BA2929F8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C26247-1B19-4E01-F9BB-5274BF08B83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CCA5599-E721-EE4E-AA66-DE9A9B96A4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48574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1716D013-930B-CD15-67D4-E3201F9555E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82365" y="403724"/>
            <a:ext cx="8747624" cy="5457294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99974B56-237E-FF1D-AEE7-443955EC8FEE}"/>
              </a:ext>
            </a:extLst>
          </p:cNvPr>
          <p:cNvSpPr txBox="1"/>
          <p:nvPr/>
        </p:nvSpPr>
        <p:spPr>
          <a:xfrm>
            <a:off x="1419300" y="6063916"/>
            <a:ext cx="98459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Supplementary Fig. 1</a:t>
            </a:r>
            <a:r>
              <a:rPr lang="en-US" sz="1800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 </a:t>
            </a:r>
            <a:r>
              <a:rPr lang="en-US" sz="1800" b="1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A representative Code Workbook on NIDAP to illustrate the SPAC Workflow.</a:t>
            </a:r>
            <a:r>
              <a:rPr lang="en-US" sz="1800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353401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A3E26F05-443B-C0B2-DE9F-ABB3851ACBB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79165" y="796365"/>
            <a:ext cx="5080000" cy="5080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2E6E365-BA30-1192-0826-0C0A3710B94B}"/>
              </a:ext>
            </a:extLst>
          </p:cNvPr>
          <p:cNvSpPr txBox="1"/>
          <p:nvPr/>
        </p:nvSpPr>
        <p:spPr>
          <a:xfrm>
            <a:off x="2348897" y="6061635"/>
            <a:ext cx="825092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latin typeface="Calibri" panose="020F0502020204030204" pitchFamily="34" charset="0"/>
                <a:cs typeface="Calibri" panose="020F0502020204030204" pitchFamily="34" charset="0"/>
              </a:rPr>
              <a:t>Supplementary Fig. </a:t>
            </a:r>
            <a:r>
              <a:rPr lang="en-US" b="1" dirty="0">
                <a:latin typeface="Calibri" panose="020F0502020204030204" pitchFamily="34" charset="0"/>
                <a:cs typeface="Calibri" panose="020F0502020204030204" pitchFamily="34" charset="0"/>
              </a:rPr>
              <a:t>2</a:t>
            </a:r>
            <a:r>
              <a:rPr lang="en-US" sz="1800" b="1" dirty="0">
                <a:latin typeface="Calibri" panose="020F0502020204030204" pitchFamily="34" charset="0"/>
                <a:cs typeface="Calibri" panose="020F0502020204030204" pitchFamily="34" charset="0"/>
              </a:rPr>
              <a:t> Hierarchical heatmap of </a:t>
            </a:r>
            <a:r>
              <a:rPr lang="en-US" sz="1800" b="1" dirty="0" err="1">
                <a:latin typeface="Calibri" panose="020F0502020204030204" pitchFamily="34" charset="0"/>
                <a:cs typeface="Calibri" panose="020F0502020204030204" pitchFamily="34" charset="0"/>
              </a:rPr>
              <a:t>PhenoGraph</a:t>
            </a:r>
            <a:r>
              <a:rPr lang="en-US" sz="1800" b="1" dirty="0">
                <a:latin typeface="Calibri" panose="020F0502020204030204" pitchFamily="34" charset="0"/>
                <a:cs typeface="Calibri" panose="020F0502020204030204" pitchFamily="34" charset="0"/>
              </a:rPr>
              <a:t> clusters. </a:t>
            </a:r>
            <a:endParaRPr lang="en-US" dirty="0"/>
          </a:p>
        </p:txBody>
      </p:sp>
      <p:sp>
        <p:nvSpPr>
          <p:cNvPr id="3" name="Rounded Rectangle 2">
            <a:extLst>
              <a:ext uri="{FF2B5EF4-FFF2-40B4-BE49-F238E27FC236}">
                <a16:creationId xmlns:a16="http://schemas.microsoft.com/office/drawing/2014/main" id="{DEF5CAB6-CB1F-714A-BA1C-1BDDC149264D}"/>
              </a:ext>
            </a:extLst>
          </p:cNvPr>
          <p:cNvSpPr/>
          <p:nvPr/>
        </p:nvSpPr>
        <p:spPr>
          <a:xfrm>
            <a:off x="3842535" y="3935002"/>
            <a:ext cx="3935002" cy="287677"/>
          </a:xfrm>
          <a:prstGeom prst="roundRect">
            <a:avLst/>
          </a:prstGeom>
          <a:noFill/>
          <a:ln>
            <a:solidFill>
              <a:srgbClr val="F551FF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ounded Rectangle 4">
            <a:extLst>
              <a:ext uri="{FF2B5EF4-FFF2-40B4-BE49-F238E27FC236}">
                <a16:creationId xmlns:a16="http://schemas.microsoft.com/office/drawing/2014/main" id="{C26F3F89-FC58-FDC9-B9A9-A53942B5E3A2}"/>
              </a:ext>
            </a:extLst>
          </p:cNvPr>
          <p:cNvSpPr/>
          <p:nvPr/>
        </p:nvSpPr>
        <p:spPr>
          <a:xfrm>
            <a:off x="3820277" y="3061698"/>
            <a:ext cx="3935002" cy="164387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C000"/>
              </a:solidFill>
            </a:endParaRPr>
          </a:p>
        </p:txBody>
      </p:sp>
      <p:sp>
        <p:nvSpPr>
          <p:cNvPr id="7" name="Rounded Rectangle 6">
            <a:extLst>
              <a:ext uri="{FF2B5EF4-FFF2-40B4-BE49-F238E27FC236}">
                <a16:creationId xmlns:a16="http://schemas.microsoft.com/office/drawing/2014/main" id="{CC1ED160-77ED-6472-58E8-974E60FB9C7E}"/>
              </a:ext>
            </a:extLst>
          </p:cNvPr>
          <p:cNvSpPr/>
          <p:nvPr/>
        </p:nvSpPr>
        <p:spPr>
          <a:xfrm>
            <a:off x="3818567" y="2546282"/>
            <a:ext cx="3935002" cy="164387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C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396032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8</Words>
  <Application>Microsoft Macintosh PowerPoint</Application>
  <PresentationFormat>Widescreen</PresentationFormat>
  <Paragraphs>4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iu, Fang (NIH/NCI) [C]</dc:creator>
  <cp:lastModifiedBy>Liu, Fang (NIH/NCI) [C]</cp:lastModifiedBy>
  <cp:revision>2</cp:revision>
  <dcterms:created xsi:type="dcterms:W3CDTF">2025-04-02T13:19:59Z</dcterms:created>
  <dcterms:modified xsi:type="dcterms:W3CDTF">2025-04-02T13:33:35Z</dcterms:modified>
</cp:coreProperties>
</file>